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1"/>
    <p:restoredTop sz="94641"/>
  </p:normalViewPr>
  <p:slideViewPr>
    <p:cSldViewPr snapToGrid="0" snapToObjects="1">
      <p:cViewPr varScale="1">
        <p:scale>
          <a:sx n="156" d="100"/>
          <a:sy n="156" d="100"/>
        </p:scale>
        <p:origin x="200" y="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EF1BA-10BA-EE44-BD12-60C321C2E6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CF8E6B-D7FD-144A-A344-D424A4C0B8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CA445F-7212-2642-A7B2-AD03E97F8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3CA021-A912-D74E-8D39-0AC097E2E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542C87-71CD-C84D-95CB-D75744DA9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05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663F4-A72F-1E47-B83A-2BBBB4A6B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F260AA-6A88-9347-9910-3B39940F6C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1B89BA-7652-EE4F-8FF8-5FCBB70E6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BB07BC-7788-BE41-A686-2D21087C3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2D3CE4-3756-734E-8A66-4F7924B14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235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4167C1-0718-AB4E-8C05-3DF2839E9B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E2DA6A-1D86-764B-9DBD-D2EAF19018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8656C6-A6F2-E840-B699-52843E270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3967F1-CE62-BA4F-86ED-B5E682DD5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E6C88D-2526-BB47-BDBD-20A555110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861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50405-3149-9B43-B5F7-21E6C12951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4C581-D660-CD41-878E-92D51EBD28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610660-440D-744F-AC36-67E5A9103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1695A-67A6-4E4E-BDBE-76717DF52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9A3BEF-F285-1E4F-B624-83D733463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85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BFBF8-95E3-3C4C-AB2C-7DBFCDD061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B14695-5AB5-5444-93FB-EDB3155564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FA3308-5576-D44A-B852-90775965E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06B71C-E543-AD42-9E9E-DE08813A7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2828B7-43E9-7A4F-A0A8-34E482F401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823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12E42B-7A8E-B942-8F86-85DC3B979C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6A32B4-E55F-9B49-867D-789426D14C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90E9CA-B5D9-FD49-96A5-E4BF4F4FBA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082E50-8F7B-6049-9108-9FE47C5DD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84A3E3-3366-184B-B65C-9168573D8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201FB5-6C65-8D41-9C8F-96791C9FD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656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10B77-5270-1D41-9573-BE586EDE80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69BDB5-45C7-384D-BBC2-1D0C0C59B3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97E954-5E3D-4643-96B0-3A20BE30DF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19AACE-B268-BA49-B182-3F8D56D77B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5F602E-A5EC-6343-AB3B-6C29760795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66B682-EDF0-6D44-A563-6E6C9074C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28A7F3-8F60-234E-8159-429C6FE71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3B0F50-6ED6-A84A-A453-ED16D4C2A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949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300843-B9FF-7D49-A433-7B64E9C262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A0E20A0-F31E-B349-A997-B3F70C04E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F1E0B93-0189-5A4F-8B15-7B40AA014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2DD513-4679-5B44-8B4A-E9E75CE5B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590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F071D2-5BDA-0D40-AA6A-AD9B674D5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AF26AFA-9CD5-ED4F-9B2F-A2FE3AB57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E20F27-B5F3-BE43-8BBD-3B155972F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82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35CB2-26F6-D044-8DA6-1D0FD0819A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A31C4B-A028-0D43-8E15-753ECCAE57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F816E3-7A19-2A4F-BB2B-E1764CF666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EC27D5-3C45-E747-8944-435BBB59A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38BF04-E9FC-B84E-B048-F87B135CA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67C1C2-DC01-0B42-A21C-F0E9E727C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081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7DC23-76BE-C643-B55F-8F8C7C4621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9BDD01-23FD-A14F-9329-E77F1C2002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24E557-C608-3244-AD12-E783EEB4C5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1C3DBA-A38D-144F-BAEE-FF27F057B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27FDFC-BD5B-9C43-8D3F-9193580A6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58D241-AF08-A449-AA03-F2290BEB5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646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B25A1F-486D-FF45-BF2B-2851854F48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CD1CA3-ECBC-DE4A-B035-C38BB7009A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52B5E6-1F1C-0E41-8851-4DFFBDB69F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FC2B4-BBA9-6345-AF88-B6BE936A77B1}" type="datetimeFigureOut">
              <a:rPr lang="en-US" smtClean="0"/>
              <a:t>2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8F8131-063C-884B-A755-304DDE16DC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2F712-B2F0-574E-B974-4016C5A97D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737F72-48C8-2347-8941-631C38BAE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62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B17A979-86F7-D64B-806D-7840C0CDE9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8047827"/>
              </p:ext>
            </p:extLst>
          </p:nvPr>
        </p:nvGraphicFramePr>
        <p:xfrm>
          <a:off x="1191008" y="657358"/>
          <a:ext cx="9193959" cy="5543284"/>
        </p:xfrm>
        <a:graphic>
          <a:graphicData uri="http://schemas.openxmlformats.org/drawingml/2006/table">
            <a:tbl>
              <a:tblPr>
                <a:tableStyleId>{EB344D84-9AFB-497E-A393-DC336BA19D2E}</a:tableStyleId>
              </a:tblPr>
              <a:tblGrid>
                <a:gridCol w="1196883">
                  <a:extLst>
                    <a:ext uri="{9D8B030D-6E8A-4147-A177-3AD203B41FA5}">
                      <a16:colId xmlns:a16="http://schemas.microsoft.com/office/drawing/2014/main" val="928363537"/>
                    </a:ext>
                  </a:extLst>
                </a:gridCol>
                <a:gridCol w="1196883">
                  <a:extLst>
                    <a:ext uri="{9D8B030D-6E8A-4147-A177-3AD203B41FA5}">
                      <a16:colId xmlns:a16="http://schemas.microsoft.com/office/drawing/2014/main" val="679836939"/>
                    </a:ext>
                  </a:extLst>
                </a:gridCol>
                <a:gridCol w="899866">
                  <a:extLst>
                    <a:ext uri="{9D8B030D-6E8A-4147-A177-3AD203B41FA5}">
                      <a16:colId xmlns:a16="http://schemas.microsoft.com/office/drawing/2014/main" val="3491390917"/>
                    </a:ext>
                  </a:extLst>
                </a:gridCol>
                <a:gridCol w="899866">
                  <a:extLst>
                    <a:ext uri="{9D8B030D-6E8A-4147-A177-3AD203B41FA5}">
                      <a16:colId xmlns:a16="http://schemas.microsoft.com/office/drawing/2014/main" val="3736606649"/>
                    </a:ext>
                  </a:extLst>
                </a:gridCol>
                <a:gridCol w="851719">
                  <a:extLst>
                    <a:ext uri="{9D8B030D-6E8A-4147-A177-3AD203B41FA5}">
                      <a16:colId xmlns:a16="http://schemas.microsoft.com/office/drawing/2014/main" val="4130417937"/>
                    </a:ext>
                  </a:extLst>
                </a:gridCol>
                <a:gridCol w="824595">
                  <a:extLst>
                    <a:ext uri="{9D8B030D-6E8A-4147-A177-3AD203B41FA5}">
                      <a16:colId xmlns:a16="http://schemas.microsoft.com/office/drawing/2014/main" val="196524306"/>
                    </a:ext>
                  </a:extLst>
                </a:gridCol>
                <a:gridCol w="784586">
                  <a:extLst>
                    <a:ext uri="{9D8B030D-6E8A-4147-A177-3AD203B41FA5}">
                      <a16:colId xmlns:a16="http://schemas.microsoft.com/office/drawing/2014/main" val="1008048991"/>
                    </a:ext>
                  </a:extLst>
                </a:gridCol>
                <a:gridCol w="813067">
                  <a:extLst>
                    <a:ext uri="{9D8B030D-6E8A-4147-A177-3AD203B41FA5}">
                      <a16:colId xmlns:a16="http://schemas.microsoft.com/office/drawing/2014/main" val="1855788417"/>
                    </a:ext>
                  </a:extLst>
                </a:gridCol>
                <a:gridCol w="863247">
                  <a:extLst>
                    <a:ext uri="{9D8B030D-6E8A-4147-A177-3AD203B41FA5}">
                      <a16:colId xmlns:a16="http://schemas.microsoft.com/office/drawing/2014/main" val="3207278021"/>
                    </a:ext>
                  </a:extLst>
                </a:gridCol>
                <a:gridCol w="863247">
                  <a:extLst>
                    <a:ext uri="{9D8B030D-6E8A-4147-A177-3AD203B41FA5}">
                      <a16:colId xmlns:a16="http://schemas.microsoft.com/office/drawing/2014/main" val="2567466942"/>
                    </a:ext>
                  </a:extLst>
                </a:gridCol>
              </a:tblGrid>
              <a:tr h="522809"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s/cases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b="1" dirty="0">
                          <a:effectLst/>
                          <a:latin typeface="Symbol" pitchFamily="2" charset="2"/>
                          <a:cs typeface="Arial" panose="020B0604020202020204" pitchFamily="34" charset="0"/>
                        </a:rPr>
                        <a:t>a- </a:t>
                      </a:r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uclein (UN)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87 </a:t>
                      </a:r>
                      <a:r>
                        <a:rPr lang="en-GB" sz="1050" b="1" dirty="0">
                          <a:effectLst/>
                          <a:latin typeface="Symbol" pitchFamily="2" charset="2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ynuclein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129 </a:t>
                      </a:r>
                      <a:r>
                        <a:rPr lang="en-GB" sz="1050" b="1" dirty="0">
                          <a:effectLst/>
                          <a:latin typeface="Symbol" pitchFamily="2" charset="2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ynuclein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Y39 </a:t>
                      </a:r>
                      <a:r>
                        <a:rPr lang="en-GB" sz="1050" b="1" dirty="0">
                          <a:effectLst/>
                          <a:latin typeface="Symbol" pitchFamily="2" charset="2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ynuclein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4317853"/>
                  </a:ext>
                </a:extLst>
              </a:tr>
              <a:tr h="451632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N</a:t>
                      </a:r>
                      <a:endParaRPr lang="en-GB" sz="12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LN</a:t>
                      </a:r>
                      <a:endParaRPr lang="en-GB" sz="12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N</a:t>
                      </a:r>
                      <a:endParaRPr lang="en-GB" sz="12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LN</a:t>
                      </a:r>
                      <a:endParaRPr lang="en-GB" sz="12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N</a:t>
                      </a:r>
                      <a:endParaRPr lang="en-GB" sz="12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LN</a:t>
                      </a:r>
                      <a:endParaRPr lang="en-GB" sz="12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N</a:t>
                      </a:r>
                      <a:endParaRPr lang="en-GB" sz="1200" b="1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LN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57361643"/>
                  </a:ext>
                </a:extLst>
              </a:tr>
              <a:tr h="503191">
                <a:tc rowSpan="3"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ly affected regions</a:t>
                      </a:r>
                      <a:endParaRPr lang="en-GB" sz="12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edulla, pons)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-stem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 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1560812"/>
                  </a:ext>
                </a:extLst>
              </a:tr>
              <a:tr h="5241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bic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 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62892006"/>
                  </a:ext>
                </a:extLst>
              </a:tr>
              <a:tr h="5318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ocortical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o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 in one case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95077978"/>
                  </a:ext>
                </a:extLst>
              </a:tr>
              <a:tr h="523243">
                <a:tc rowSpan="3"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d-way affected regions</a:t>
                      </a:r>
                      <a:endParaRPr lang="en-GB" sz="12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. nigra, cingulate)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-stem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45286856"/>
                  </a:ext>
                </a:extLst>
              </a:tr>
              <a:tr h="2406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bic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o 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o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+++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92180554"/>
                  </a:ext>
                </a:extLst>
              </a:tr>
              <a:tr h="5206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ocortical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o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o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to 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40453392"/>
                  </a:ext>
                </a:extLst>
              </a:tr>
              <a:tr h="520604">
                <a:tc rowSpan="3"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e </a:t>
                      </a:r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fected regions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frontal, parietal and temporal cortices)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 stem 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 in two cases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67355730"/>
                  </a:ext>
                </a:extLst>
              </a:tr>
              <a:tr h="4812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bic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in one case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60318711"/>
                  </a:ext>
                </a:extLst>
              </a:tr>
              <a:tr h="6038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ocortical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o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to ++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endParaRPr lang="en-GB" sz="10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o+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81646541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10ACFCE7-5319-BA47-B731-5A707B400A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5037" y="100965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561F28D-1E22-B04A-97C6-40091AB23034}"/>
              </a:ext>
            </a:extLst>
          </p:cNvPr>
          <p:cNvCxnSpPr/>
          <p:nvPr/>
        </p:nvCxnSpPr>
        <p:spPr>
          <a:xfrm>
            <a:off x="1201896" y="1466850"/>
            <a:ext cx="919395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93E7141-4B82-EF43-9494-81A8AFF703F9}"/>
              </a:ext>
            </a:extLst>
          </p:cNvPr>
          <p:cNvCxnSpPr/>
          <p:nvPr/>
        </p:nvCxnSpPr>
        <p:spPr>
          <a:xfrm>
            <a:off x="1201894" y="3026228"/>
            <a:ext cx="919395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AA399E36-9B6B-034C-9236-68546426BDCE}"/>
              </a:ext>
            </a:extLst>
          </p:cNvPr>
          <p:cNvCxnSpPr/>
          <p:nvPr/>
        </p:nvCxnSpPr>
        <p:spPr>
          <a:xfrm>
            <a:off x="1201895" y="4572001"/>
            <a:ext cx="919395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675DD49-8D47-9B45-8F12-C61A9813F384}"/>
              </a:ext>
            </a:extLst>
          </p:cNvPr>
          <p:cNvCxnSpPr>
            <a:cxnSpLocks/>
          </p:cNvCxnSpPr>
          <p:nvPr/>
        </p:nvCxnSpPr>
        <p:spPr>
          <a:xfrm>
            <a:off x="3788228" y="1085849"/>
            <a:ext cx="6596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F569C47D-32BA-5D4C-90B8-5DBCB10F2247}"/>
              </a:ext>
            </a:extLst>
          </p:cNvPr>
          <p:cNvSpPr txBox="1"/>
          <p:nvPr/>
        </p:nvSpPr>
        <p:spPr>
          <a:xfrm>
            <a:off x="673100" y="143239"/>
            <a:ext cx="10789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emiquantitative assessment of Lewy neurites in IPD cases.  Key to scores: - = none; +=mild; ++= moderate; +++= severe.</a:t>
            </a:r>
            <a:r>
              <a:rPr lang="en-GB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1210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269</Words>
  <Application>Microsoft Macintosh PowerPoint</Application>
  <PresentationFormat>Widescreen</PresentationFormat>
  <Paragraphs>1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ndopadhyay, Rina</dc:creator>
  <cp:lastModifiedBy>Bandopadhyay, Rina</cp:lastModifiedBy>
  <cp:revision>14</cp:revision>
  <dcterms:created xsi:type="dcterms:W3CDTF">2022-01-12T18:58:44Z</dcterms:created>
  <dcterms:modified xsi:type="dcterms:W3CDTF">2022-02-25T13:02:35Z</dcterms:modified>
</cp:coreProperties>
</file>